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00584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9F3D"/>
    <a:srgbClr val="171BB9"/>
    <a:srgbClr val="00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188" y="114"/>
      </p:cViewPr>
      <p:guideLst>
        <p:guide orient="horz" pos="2160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122363"/>
            <a:ext cx="854964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602038"/>
            <a:ext cx="75438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762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970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365125"/>
            <a:ext cx="2168843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65125"/>
            <a:ext cx="6380798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312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148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709740"/>
            <a:ext cx="867537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4589465"/>
            <a:ext cx="867537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585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825625"/>
            <a:ext cx="427482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825625"/>
            <a:ext cx="427482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81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65127"/>
            <a:ext cx="867537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681163"/>
            <a:ext cx="425517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505075"/>
            <a:ext cx="4255174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681163"/>
            <a:ext cx="427613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505075"/>
            <a:ext cx="427613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136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25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493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57200"/>
            <a:ext cx="324409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987427"/>
            <a:ext cx="509206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057400"/>
            <a:ext cx="324409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614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57200"/>
            <a:ext cx="324409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987427"/>
            <a:ext cx="509206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057400"/>
            <a:ext cx="324409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926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65127"/>
            <a:ext cx="86753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825625"/>
            <a:ext cx="86753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6356352"/>
            <a:ext cx="22631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6AC01-30F2-42A4-96B0-C251074A43B3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6356352"/>
            <a:ext cx="33947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6356352"/>
            <a:ext cx="22631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2B3A5-1EB0-45B1-964D-665A4C2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151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46878" y="814373"/>
            <a:ext cx="7846883" cy="5104027"/>
            <a:chOff x="1327262" y="814373"/>
            <a:chExt cx="7846883" cy="510402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2"/>
            <a:srcRect t="9362"/>
            <a:stretch/>
          </p:blipFill>
          <p:spPr>
            <a:xfrm>
              <a:off x="2668681" y="814373"/>
              <a:ext cx="3821135" cy="225148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3"/>
            <a:srcRect t="7170" r="4254"/>
            <a:stretch/>
          </p:blipFill>
          <p:spPr>
            <a:xfrm>
              <a:off x="2668681" y="3643831"/>
              <a:ext cx="3821135" cy="2274569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327262" y="1050532"/>
              <a:ext cx="9687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Father </a:t>
              </a:r>
              <a:r>
                <a:rPr lang="en-US" sz="1600" dirty="0" smtClean="0">
                  <a:solidFill>
                    <a:srgbClr val="FF0000"/>
                  </a:solidFill>
                </a:rPr>
                <a:t>TT</a:t>
              </a:r>
              <a:endParaRPr 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27262" y="1763734"/>
              <a:ext cx="10839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Mother </a:t>
              </a:r>
              <a:r>
                <a:rPr lang="en-US" sz="1600" dirty="0" smtClean="0">
                  <a:solidFill>
                    <a:srgbClr val="171BB9"/>
                  </a:solidFill>
                </a:rPr>
                <a:t>CC</a:t>
              </a:r>
              <a:endParaRPr lang="en-US" sz="1600" dirty="0">
                <a:solidFill>
                  <a:srgbClr val="171BB9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327262" y="2462306"/>
              <a:ext cx="9201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Patient </a:t>
              </a:r>
              <a:r>
                <a:rPr lang="en-US" sz="1600" dirty="0" smtClean="0">
                  <a:solidFill>
                    <a:srgbClr val="FF0000"/>
                  </a:solidFill>
                </a:rPr>
                <a:t>T</a:t>
              </a:r>
              <a:endParaRPr 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333099" y="4567226"/>
              <a:ext cx="10043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Father </a:t>
              </a:r>
              <a:r>
                <a:rPr lang="en-US" sz="1600" dirty="0" smtClean="0">
                  <a:solidFill>
                    <a:srgbClr val="119F3D"/>
                  </a:solidFill>
                </a:rPr>
                <a:t>AA</a:t>
              </a:r>
              <a:endParaRPr lang="en-US" sz="1600" dirty="0">
                <a:solidFill>
                  <a:srgbClr val="119F3D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333099" y="3865613"/>
              <a:ext cx="11256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Mother GG</a:t>
              </a:r>
              <a:endParaRPr lang="en-US" sz="1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33099" y="5254384"/>
              <a:ext cx="9394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Patient </a:t>
              </a:r>
              <a:r>
                <a:rPr lang="en-US" sz="1600" dirty="0" smtClean="0">
                  <a:solidFill>
                    <a:srgbClr val="00B050"/>
                  </a:solidFill>
                </a:rPr>
                <a:t>A</a:t>
              </a:r>
              <a:endParaRPr lang="en-US" sz="1600" dirty="0">
                <a:solidFill>
                  <a:srgbClr val="00B050"/>
                </a:solidFill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6911980" y="1703746"/>
              <a:ext cx="2252118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err="1"/>
                <a:t>dbSNP</a:t>
              </a:r>
              <a:r>
                <a:rPr lang="en-US" sz="1000" dirty="0"/>
                <a:t>: rs11640208</a:t>
              </a:r>
            </a:p>
            <a:p>
              <a:r>
                <a:rPr lang="en-US" sz="1000" dirty="0"/>
                <a:t>Position: </a:t>
              </a:r>
              <a:r>
                <a:rPr lang="en-US" sz="1000" dirty="0" smtClean="0"/>
                <a:t>chr16:86,215,137-86,215,137</a:t>
              </a:r>
              <a:endParaRPr lang="en-US" sz="1000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6911979" y="4510716"/>
              <a:ext cx="226216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err="1"/>
                <a:t>dbSNP</a:t>
              </a:r>
              <a:r>
                <a:rPr lang="en-US" sz="1000" dirty="0"/>
                <a:t>: </a:t>
              </a:r>
              <a:r>
                <a:rPr lang="en-US" sz="1000" dirty="0" smtClean="0"/>
                <a:t>rs11641863 C/G/T</a:t>
              </a:r>
              <a:endParaRPr lang="en-US" sz="1000" dirty="0"/>
            </a:p>
            <a:p>
              <a:r>
                <a:rPr lang="en-US" sz="1000" dirty="0"/>
                <a:t>Position: </a:t>
              </a:r>
              <a:r>
                <a:rPr lang="en-US" sz="1000" dirty="0" smtClean="0"/>
                <a:t>chr16:86,216,619-86,216,619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94120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5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franski, Przemyslaw</dc:creator>
  <cp:lastModifiedBy>Szafranski, Przemyslaw</cp:lastModifiedBy>
  <cp:revision>8</cp:revision>
  <dcterms:created xsi:type="dcterms:W3CDTF">2022-10-19T19:53:43Z</dcterms:created>
  <dcterms:modified xsi:type="dcterms:W3CDTF">2023-09-13T03:16:44Z</dcterms:modified>
</cp:coreProperties>
</file>